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71" r:id="rId2"/>
    <p:sldId id="272" r:id="rId3"/>
    <p:sldId id="275" r:id="rId4"/>
    <p:sldId id="274" r:id="rId5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FF99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DF18680-E054-41AD-8BC1-D1AEF772440D}" styleName="中間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2838BEF-8BB2-4498-84A7-C5851F593DF1}" styleName="中間 4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  <a:tblStyle styleId="{BDBED569-4797-4DF1-A0F4-6AAB3CD982D8}" styleName="淡色 3 - アクセント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5A111915-BE36-4E01-A7E5-04B1672EAD32}" styleName="淡色 2 - アクセント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74C1A8A3-306A-4EB7-A6B1-4F7E0EB9C5D6}" styleName="中間 3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37"/>
    <p:restoredTop sz="94728"/>
  </p:normalViewPr>
  <p:slideViewPr>
    <p:cSldViewPr snapToGrid="0" snapToObjects="1">
      <p:cViewPr>
        <p:scale>
          <a:sx n="100" d="100"/>
          <a:sy n="100" d="100"/>
        </p:scale>
        <p:origin x="1584" y="1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71F1E-35CF-8449-B55B-A3F1511E373B}" type="datetimeFigureOut">
              <a:rPr kumimoji="1" lang="ja-JP" altLang="en-US" smtClean="0"/>
              <a:t>2021/3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E279076-4550-7844-8AD1-40F6E40AFA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57090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E279076-4550-7844-8AD1-40F6E40AFAC5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81599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BD63-3890-8240-A818-A5145D93FB84}" type="datetimeFigureOut">
              <a:rPr kumimoji="1" lang="ja-JP" altLang="en-US" smtClean="0"/>
              <a:t>2021/3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89868-F636-D94D-A7C4-B6A8ACA5F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75511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BD63-3890-8240-A818-A5145D93FB84}" type="datetimeFigureOut">
              <a:rPr kumimoji="1" lang="ja-JP" altLang="en-US" smtClean="0"/>
              <a:t>2021/3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89868-F636-D94D-A7C4-B6A8ACA5F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20513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BD63-3890-8240-A818-A5145D93FB84}" type="datetimeFigureOut">
              <a:rPr kumimoji="1" lang="ja-JP" altLang="en-US" smtClean="0"/>
              <a:t>2021/3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89868-F636-D94D-A7C4-B6A8ACA5F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352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BD63-3890-8240-A818-A5145D93FB84}" type="datetimeFigureOut">
              <a:rPr kumimoji="1" lang="ja-JP" altLang="en-US" smtClean="0"/>
              <a:t>2021/3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89868-F636-D94D-A7C4-B6A8ACA5F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71856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BD63-3890-8240-A818-A5145D93FB84}" type="datetimeFigureOut">
              <a:rPr kumimoji="1" lang="ja-JP" altLang="en-US" smtClean="0"/>
              <a:t>2021/3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89868-F636-D94D-A7C4-B6A8ACA5F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6410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BD63-3890-8240-A818-A5145D93FB84}" type="datetimeFigureOut">
              <a:rPr kumimoji="1" lang="ja-JP" altLang="en-US" smtClean="0"/>
              <a:t>2021/3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89868-F636-D94D-A7C4-B6A8ACA5F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8699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BD63-3890-8240-A818-A5145D93FB84}" type="datetimeFigureOut">
              <a:rPr kumimoji="1" lang="ja-JP" altLang="en-US" smtClean="0"/>
              <a:t>2021/3/1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89868-F636-D94D-A7C4-B6A8ACA5F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0526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BD63-3890-8240-A818-A5145D93FB84}" type="datetimeFigureOut">
              <a:rPr kumimoji="1" lang="ja-JP" altLang="en-US" smtClean="0"/>
              <a:t>2021/3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89868-F636-D94D-A7C4-B6A8ACA5F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946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BD63-3890-8240-A818-A5145D93FB84}" type="datetimeFigureOut">
              <a:rPr kumimoji="1" lang="ja-JP" altLang="en-US" smtClean="0"/>
              <a:t>2021/3/1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89868-F636-D94D-A7C4-B6A8ACA5F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4274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BD63-3890-8240-A818-A5145D93FB84}" type="datetimeFigureOut">
              <a:rPr kumimoji="1" lang="ja-JP" altLang="en-US" smtClean="0"/>
              <a:t>2021/3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89868-F636-D94D-A7C4-B6A8ACA5F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7683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49BD63-3890-8240-A818-A5145D93FB84}" type="datetimeFigureOut">
              <a:rPr kumimoji="1" lang="ja-JP" altLang="en-US" smtClean="0"/>
              <a:t>2021/3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89868-F636-D94D-A7C4-B6A8ACA5F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41332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9BD63-3890-8240-A818-A5145D93FB84}" type="datetimeFigureOut">
              <a:rPr kumimoji="1" lang="ja-JP" altLang="en-US" smtClean="0"/>
              <a:t>2021/3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B89868-F636-D94D-A7C4-B6A8ACA5FA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8673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mp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m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mp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FBF3D459-1339-4EA0-8814-BD3635C878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955" y="1337587"/>
            <a:ext cx="8786089" cy="4182826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D7E16F9-5D37-4D88-80A4-A656AD28424A}"/>
              </a:ext>
            </a:extLst>
          </p:cNvPr>
          <p:cNvSpPr txBox="1"/>
          <p:nvPr/>
        </p:nvSpPr>
        <p:spPr>
          <a:xfrm>
            <a:off x="0" y="21034"/>
            <a:ext cx="38512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al Leaflet for </a:t>
            </a:r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Vaccinated Women.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BE495B3-B73E-A144-B0BF-7D419C264189}"/>
              </a:ext>
            </a:extLst>
          </p:cNvPr>
          <p:cNvSpPr txBox="1"/>
          <p:nvPr/>
        </p:nvSpPr>
        <p:spPr>
          <a:xfrm>
            <a:off x="1881809" y="5738191"/>
            <a:ext cx="47972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A 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prising phenomenon in the body of a young woman in her 20s.”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56086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933C5920-8762-4078-8291-239992C3765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8316"/>
            <a:ext cx="5632174" cy="5413094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C330095A-417D-3A40-832C-007552F76F34}"/>
              </a:ext>
            </a:extLst>
          </p:cNvPr>
          <p:cNvSpPr/>
          <p:nvPr/>
        </p:nvSpPr>
        <p:spPr>
          <a:xfrm>
            <a:off x="5516710" y="325472"/>
            <a:ext cx="362729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 is the leading cause of deaths, excluding suicide, among women in </a:t>
            </a:r>
            <a:b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ir 20s.”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Every year, 1.7 times as many women die from cervical cancer as from car accidents.”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The risk is present in most women.</a:t>
            </a: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E0948613-4CA6-D143-89EA-D5E6D531286B}"/>
              </a:ext>
            </a:extLst>
          </p:cNvPr>
          <p:cNvSpPr/>
          <p:nvPr/>
        </p:nvSpPr>
        <p:spPr>
          <a:xfrm>
            <a:off x="4690106" y="2689948"/>
            <a:ext cx="4572000" cy="4247317"/>
          </a:xfrm>
          <a:prstGeom prst="rect">
            <a:avLst/>
          </a:prstGeom>
        </p:spPr>
        <p:txBody>
          <a:bodyPr>
            <a:spAutoFit/>
          </a:bodyPr>
          <a:lstStyle/>
          <a:p>
            <a:endParaRPr lang="en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The risk is present in most women.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ain cause of cervical cancer is the human papillomavirus, which is transmitted through sexual intercourse.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t is a very common virus that infects most women, so even if you have had little sexual experience, you are still at risk.”</a:t>
            </a:r>
          </a:p>
          <a:p>
            <a:endParaRPr lang="en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The Ministry of Health,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bour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Welfare (MHLW) recommends that women aged 20 or </a:t>
            </a:r>
            <a:r>
              <a:rPr lang="en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lderundergo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rvical cancer screening every two years. It's very important to protect your health and your life.”</a:t>
            </a:r>
            <a:b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64460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BDA2B942-D942-4FF3-BF7A-F032871AAC4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017" y="152636"/>
            <a:ext cx="7284809" cy="6552728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0F78AF9-4C30-CD49-A60C-5E63AB92ECC0}"/>
              </a:ext>
            </a:extLst>
          </p:cNvPr>
          <p:cNvSpPr txBox="1"/>
          <p:nvPr/>
        </p:nvSpPr>
        <p:spPr>
          <a:xfrm>
            <a:off x="6440556" y="429635"/>
            <a:ext cx="270344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Cervical cancer screening will find cancer cells, but also can prevent </a:t>
            </a:r>
            <a:b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 by detecting premalignant cells.”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213DB05-925B-EC40-A374-49FD03A082D8}"/>
              </a:ext>
            </a:extLst>
          </p:cNvPr>
          <p:cNvSpPr txBox="1"/>
          <p:nvPr/>
        </p:nvSpPr>
        <p:spPr>
          <a:xfrm>
            <a:off x="3934326" y="2815389"/>
            <a:ext cx="2040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malignant cells.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C37CAD8-30E6-0045-9D66-D53DC1F191DD}"/>
              </a:ext>
            </a:extLst>
          </p:cNvPr>
          <p:cNvSpPr txBox="1"/>
          <p:nvPr/>
        </p:nvSpPr>
        <p:spPr>
          <a:xfrm>
            <a:off x="6440556" y="3544469"/>
            <a:ext cx="2666385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It is a medical examination.”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A spatula or brush is used to gently scrape the uterine cervix to collect cells.”</a:t>
            </a:r>
          </a:p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The procedure takes only a few minutes. There is almost no pain.”</a:t>
            </a:r>
          </a:p>
          <a:p>
            <a:r>
              <a:rPr kumimoji="1"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You can receive cervical cancer screening at nearby clinics.”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6FDDFBB-CAF4-4347-899A-1E43B232075F}"/>
              </a:ext>
            </a:extLst>
          </p:cNvPr>
          <p:cNvSpPr txBox="1"/>
          <p:nvPr/>
        </p:nvSpPr>
        <p:spPr>
          <a:xfrm>
            <a:off x="794084" y="2815389"/>
            <a:ext cx="11309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mal cell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1156C65-4B86-4B42-A4A0-F835F1252171}"/>
              </a:ext>
            </a:extLst>
          </p:cNvPr>
          <p:cNvSpPr txBox="1"/>
          <p:nvPr/>
        </p:nvSpPr>
        <p:spPr>
          <a:xfrm>
            <a:off x="2186895" y="2661501"/>
            <a:ext cx="156152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infected with human papillomavirus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1392A0A2-E5C7-F144-864D-6D84C3C9615D}"/>
              </a:ext>
            </a:extLst>
          </p:cNvPr>
          <p:cNvSpPr/>
          <p:nvPr/>
        </p:nvSpPr>
        <p:spPr>
          <a:xfrm>
            <a:off x="5750537" y="2682399"/>
            <a:ext cx="82105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" altLang="ja-JP" sz="1100" dirty="0">
                <a:solidFill>
                  <a:srgbClr val="22222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ncer cell</a:t>
            </a:r>
            <a:endParaRPr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19361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8F9DA8DC-7CF8-4EF9-AF8F-31419D3224A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962" y="750477"/>
            <a:ext cx="8632076" cy="4176464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56E38CD-250C-D440-BB6E-C592EA1DC8F0}"/>
              </a:ext>
            </a:extLst>
          </p:cNvPr>
          <p:cNvSpPr txBox="1"/>
          <p:nvPr/>
        </p:nvSpPr>
        <p:spPr>
          <a:xfrm>
            <a:off x="914400" y="5100605"/>
            <a:ext cx="78867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t is strongly recommended that you take a cervical cancer screening even if you have received the HPV vaccine. Vaccines are not 100% effective, just as you can still get the flu even if you have received the flu vaccine..”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BE92EA4-65E5-A543-AA08-08A5B6A43739}"/>
              </a:ext>
            </a:extLst>
          </p:cNvPr>
          <p:cNvSpPr txBox="1"/>
          <p:nvPr/>
        </p:nvSpPr>
        <p:spPr>
          <a:xfrm>
            <a:off x="914400" y="6197600"/>
            <a:ext cx="6718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”Name of City”</a:t>
            </a:r>
            <a:r>
              <a:rPr lang="ja-JP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“</a:t>
            </a:r>
            <a:r>
              <a:rPr lang="en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ation of clinics” / “Contact address”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865458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40</TotalTime>
  <Words>306</Words>
  <Application>Microsoft Macintosh PowerPoint</Application>
  <PresentationFormat>画面に合わせる (4:3)</PresentationFormat>
  <Paragraphs>24</Paragraphs>
  <Slides>4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ワクチン接種の有無別の検診受診勧奨手法の開発</dc:title>
  <dc:creator>橋村 茉利子</dc:creator>
  <cp:lastModifiedBy>Microsoft Office User</cp:lastModifiedBy>
  <cp:revision>47</cp:revision>
  <dcterms:created xsi:type="dcterms:W3CDTF">2019-03-12T06:24:50Z</dcterms:created>
  <dcterms:modified xsi:type="dcterms:W3CDTF">2021-03-13T07:36:36Z</dcterms:modified>
</cp:coreProperties>
</file>